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03"/>
    <p:restoredTop sz="89252"/>
  </p:normalViewPr>
  <p:slideViewPr>
    <p:cSldViewPr snapToGrid="0" snapToObjects="1">
      <p:cViewPr varScale="1">
        <p:scale>
          <a:sx n="114" d="100"/>
          <a:sy n="114" d="100"/>
        </p:scale>
        <p:origin x="18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B0EACF-48F0-5B4F-B4A1-8067BC58A3E0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5BE75B-1058-4F43-83B3-24D50C6F6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222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5BE75B-1058-4F43-83B3-24D50C6F6A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47369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537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3946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199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777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031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536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237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657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993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786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021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8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89E560F5-7245-5742-93F2-598FCAEDA2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834" b="11742"/>
          <a:stretch/>
        </p:blipFill>
        <p:spPr>
          <a:xfrm>
            <a:off x="5142636" y="1052254"/>
            <a:ext cx="2765522" cy="2507403"/>
          </a:xfrm>
          <a:prstGeom prst="rect">
            <a:avLst/>
          </a:prstGeom>
        </p:spPr>
      </p:pic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C11127C5-0021-A743-86F9-75C1A3795E27}"/>
              </a:ext>
            </a:extLst>
          </p:cNvPr>
          <p:cNvSpPr/>
          <p:nvPr/>
        </p:nvSpPr>
        <p:spPr>
          <a:xfrm>
            <a:off x="5147616" y="1050808"/>
            <a:ext cx="2599143" cy="24056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EEAC2A65-2236-3948-B2E7-A223430BB9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275" t="2984" r="863" b="12444"/>
          <a:stretch/>
        </p:blipFill>
        <p:spPr>
          <a:xfrm>
            <a:off x="6472986" y="1139638"/>
            <a:ext cx="2599143" cy="240270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4194A56B-AF69-6945-A1BD-0050BF7BE0C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264" t="8788" r="7689" b="11741"/>
          <a:stretch/>
        </p:blipFill>
        <p:spPr>
          <a:xfrm>
            <a:off x="5154065" y="1301913"/>
            <a:ext cx="1318920" cy="2257746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12F4979-2822-5643-9CCE-033D2701F473}"/>
              </a:ext>
            </a:extLst>
          </p:cNvPr>
          <p:cNvSpPr txBox="1"/>
          <p:nvPr/>
        </p:nvSpPr>
        <p:spPr>
          <a:xfrm rot="16200000">
            <a:off x="2999803" y="2107533"/>
            <a:ext cx="356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3K27me3 labelling index (%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左大かっこ 44">
            <a:extLst>
              <a:ext uri="{FF2B5EF4-FFF2-40B4-BE49-F238E27FC236}">
                <a16:creationId xmlns:a16="http://schemas.microsoft.com/office/drawing/2014/main" id="{EED25DF8-26A8-7B4A-86AA-74DF65F83263}"/>
              </a:ext>
            </a:extLst>
          </p:cNvPr>
          <p:cNvSpPr/>
          <p:nvPr/>
        </p:nvSpPr>
        <p:spPr>
          <a:xfrm rot="5400000">
            <a:off x="6401984" y="435719"/>
            <a:ext cx="51292" cy="1176967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左大かっこ 45">
            <a:extLst>
              <a:ext uri="{FF2B5EF4-FFF2-40B4-BE49-F238E27FC236}">
                <a16:creationId xmlns:a16="http://schemas.microsoft.com/office/drawing/2014/main" id="{F38C0A70-72F4-5E41-930A-C7B56A4DB06A}"/>
              </a:ext>
            </a:extLst>
          </p:cNvPr>
          <p:cNvSpPr/>
          <p:nvPr/>
        </p:nvSpPr>
        <p:spPr>
          <a:xfrm rot="5400000">
            <a:off x="7005077" y="-532567"/>
            <a:ext cx="45719" cy="2377581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EB405E4-4C12-704C-A5E5-A6264CE2162A}"/>
              </a:ext>
            </a:extLst>
          </p:cNvPr>
          <p:cNvSpPr txBox="1"/>
          <p:nvPr/>
        </p:nvSpPr>
        <p:spPr>
          <a:xfrm>
            <a:off x="5888793" y="661970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38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85B99CB-228C-E34D-81D3-58283D104F50}"/>
              </a:ext>
            </a:extLst>
          </p:cNvPr>
          <p:cNvSpPr txBox="1"/>
          <p:nvPr/>
        </p:nvSpPr>
        <p:spPr>
          <a:xfrm>
            <a:off x="6489099" y="291593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BC7995B-A762-2D46-9BC8-F0F968499CFA}"/>
              </a:ext>
            </a:extLst>
          </p:cNvPr>
          <p:cNvSpPr txBox="1"/>
          <p:nvPr/>
        </p:nvSpPr>
        <p:spPr>
          <a:xfrm>
            <a:off x="4641814" y="173632"/>
            <a:ext cx="311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E211F48-C1F6-BB49-AD9E-D99650AF0606}"/>
              </a:ext>
            </a:extLst>
          </p:cNvPr>
          <p:cNvSpPr txBox="1"/>
          <p:nvPr/>
        </p:nvSpPr>
        <p:spPr>
          <a:xfrm>
            <a:off x="5174307" y="3502248"/>
            <a:ext cx="131173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rmal salivary glan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00EA741-8ECF-F941-B153-4F2017ADB8D6}"/>
              </a:ext>
            </a:extLst>
          </p:cNvPr>
          <p:cNvSpPr txBox="1"/>
          <p:nvPr/>
        </p:nvSpPr>
        <p:spPr>
          <a:xfrm>
            <a:off x="6420926" y="3502248"/>
            <a:ext cx="12002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leomorphic adenom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3E2BC48-1E67-7C40-8012-ABE416F522FB}"/>
              </a:ext>
            </a:extLst>
          </p:cNvPr>
          <p:cNvSpPr txBox="1"/>
          <p:nvPr/>
        </p:nvSpPr>
        <p:spPr>
          <a:xfrm>
            <a:off x="7615756" y="3502248"/>
            <a:ext cx="12147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livary duct carcinom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左大かっこ 36">
            <a:extLst>
              <a:ext uri="{FF2B5EF4-FFF2-40B4-BE49-F238E27FC236}">
                <a16:creationId xmlns:a16="http://schemas.microsoft.com/office/drawing/2014/main" id="{AACE73F5-F01B-AB44-B838-D56016FA2640}"/>
              </a:ext>
            </a:extLst>
          </p:cNvPr>
          <p:cNvSpPr/>
          <p:nvPr/>
        </p:nvSpPr>
        <p:spPr>
          <a:xfrm rot="5400000">
            <a:off x="7600740" y="433861"/>
            <a:ext cx="55009" cy="1176967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1923626-C140-C647-9B14-51E0F3062F8C}"/>
              </a:ext>
            </a:extLst>
          </p:cNvPr>
          <p:cNvSpPr txBox="1"/>
          <p:nvPr/>
        </p:nvSpPr>
        <p:spPr>
          <a:xfrm>
            <a:off x="7089407" y="661970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885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B71E476E-F107-8648-9686-E44F84196A2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909" r="-4882" b="11316"/>
          <a:stretch/>
        </p:blipFill>
        <p:spPr>
          <a:xfrm>
            <a:off x="593998" y="788179"/>
            <a:ext cx="3036883" cy="2780907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C207E91-E08D-8749-AFAF-022A3676A7FC}"/>
              </a:ext>
            </a:extLst>
          </p:cNvPr>
          <p:cNvSpPr/>
          <p:nvPr/>
        </p:nvSpPr>
        <p:spPr>
          <a:xfrm>
            <a:off x="840276" y="1167004"/>
            <a:ext cx="3068298" cy="2285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51CD2AB-A265-2947-9887-2DAC0CA83EE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844" t="8187" r="3069" b="12093"/>
          <a:stretch/>
        </p:blipFill>
        <p:spPr>
          <a:xfrm>
            <a:off x="2040484" y="1049848"/>
            <a:ext cx="2492780" cy="2493624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32CF992-3A1F-904B-892F-6471304FA75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4993" t="15953" r="8202" b="11316"/>
          <a:stretch/>
        </p:blipFill>
        <p:spPr>
          <a:xfrm>
            <a:off x="983595" y="1288418"/>
            <a:ext cx="1106953" cy="228066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4CE4F3B-0301-434B-8892-9E085FA9556E}"/>
              </a:ext>
            </a:extLst>
          </p:cNvPr>
          <p:cNvSpPr txBox="1"/>
          <p:nvPr/>
        </p:nvSpPr>
        <p:spPr>
          <a:xfrm rot="16200000">
            <a:off x="-1108917" y="2068971"/>
            <a:ext cx="2953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ZH2 labelling index (%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30F04C2-4A03-4A48-8894-03CF4EDC1D4B}"/>
              </a:ext>
            </a:extLst>
          </p:cNvPr>
          <p:cNvSpPr txBox="1"/>
          <p:nvPr/>
        </p:nvSpPr>
        <p:spPr>
          <a:xfrm>
            <a:off x="842573" y="3505834"/>
            <a:ext cx="13117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ormal salivary gland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8F13F90-A26A-D74B-B00B-FD99F619A54B}"/>
              </a:ext>
            </a:extLst>
          </p:cNvPr>
          <p:cNvSpPr txBox="1"/>
          <p:nvPr/>
        </p:nvSpPr>
        <p:spPr>
          <a:xfrm>
            <a:off x="2040781" y="3505834"/>
            <a:ext cx="12002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leomorphic adenom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4A9632A-EBEB-014E-9306-D316B4CE41C7}"/>
              </a:ext>
            </a:extLst>
          </p:cNvPr>
          <p:cNvSpPr txBox="1"/>
          <p:nvPr/>
        </p:nvSpPr>
        <p:spPr>
          <a:xfrm>
            <a:off x="3176445" y="3505834"/>
            <a:ext cx="12147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livary duct carcinom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左大かっこ 40">
            <a:extLst>
              <a:ext uri="{FF2B5EF4-FFF2-40B4-BE49-F238E27FC236}">
                <a16:creationId xmlns:a16="http://schemas.microsoft.com/office/drawing/2014/main" id="{A14B24AB-2CAB-DB47-8B50-15AE641734D9}"/>
              </a:ext>
            </a:extLst>
          </p:cNvPr>
          <p:cNvSpPr/>
          <p:nvPr/>
        </p:nvSpPr>
        <p:spPr>
          <a:xfrm rot="5400000">
            <a:off x="2040167" y="469833"/>
            <a:ext cx="54511" cy="1091232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左大かっこ 42">
            <a:extLst>
              <a:ext uri="{FF2B5EF4-FFF2-40B4-BE49-F238E27FC236}">
                <a16:creationId xmlns:a16="http://schemas.microsoft.com/office/drawing/2014/main" id="{0CC50239-7897-7C4A-925D-0A611EDD2B54}"/>
              </a:ext>
            </a:extLst>
          </p:cNvPr>
          <p:cNvSpPr/>
          <p:nvPr/>
        </p:nvSpPr>
        <p:spPr>
          <a:xfrm rot="5400000">
            <a:off x="3176789" y="448225"/>
            <a:ext cx="54380" cy="1134586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左大かっこ 43">
            <a:extLst>
              <a:ext uri="{FF2B5EF4-FFF2-40B4-BE49-F238E27FC236}">
                <a16:creationId xmlns:a16="http://schemas.microsoft.com/office/drawing/2014/main" id="{F4D065A8-8AA8-194A-9D67-834F3B7A40C3}"/>
              </a:ext>
            </a:extLst>
          </p:cNvPr>
          <p:cNvSpPr/>
          <p:nvPr/>
        </p:nvSpPr>
        <p:spPr>
          <a:xfrm rot="5400000">
            <a:off x="2620213" y="-477259"/>
            <a:ext cx="45975" cy="2255220"/>
          </a:xfrm>
          <a:prstGeom prst="lef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91206DA-52D9-4F4B-813E-9C6F05C9E7D0}"/>
              </a:ext>
            </a:extLst>
          </p:cNvPr>
          <p:cNvSpPr txBox="1"/>
          <p:nvPr/>
        </p:nvSpPr>
        <p:spPr>
          <a:xfrm>
            <a:off x="1528585" y="656400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= 0.002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810A281-D565-D842-B2C6-378ACDF80AF8}"/>
              </a:ext>
            </a:extLst>
          </p:cNvPr>
          <p:cNvSpPr txBox="1"/>
          <p:nvPr/>
        </p:nvSpPr>
        <p:spPr>
          <a:xfrm>
            <a:off x="2692131" y="649639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57718CC-C91C-8249-85ED-FF6FF2320894}"/>
              </a:ext>
            </a:extLst>
          </p:cNvPr>
          <p:cNvSpPr txBox="1"/>
          <p:nvPr/>
        </p:nvSpPr>
        <p:spPr>
          <a:xfrm>
            <a:off x="2104363" y="291593"/>
            <a:ext cx="10776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F6DF505-0371-744D-99F7-B83ABD891621}"/>
              </a:ext>
            </a:extLst>
          </p:cNvPr>
          <p:cNvSpPr txBox="1"/>
          <p:nvPr/>
        </p:nvSpPr>
        <p:spPr>
          <a:xfrm>
            <a:off x="238996" y="178849"/>
            <a:ext cx="311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F7EF22A-28FD-CA45-9CBF-B46A1633B58D}"/>
              </a:ext>
            </a:extLst>
          </p:cNvPr>
          <p:cNvSpPr/>
          <p:nvPr/>
        </p:nvSpPr>
        <p:spPr>
          <a:xfrm>
            <a:off x="829171" y="1157545"/>
            <a:ext cx="3609496" cy="23025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52" name="図 51">
            <a:extLst>
              <a:ext uri="{FF2B5EF4-FFF2-40B4-BE49-F238E27FC236}">
                <a16:creationId xmlns:a16="http://schemas.microsoft.com/office/drawing/2014/main" id="{5978FEF8-346C-AB4F-AD3D-E651C1077EC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909" r="88236" b="11316"/>
          <a:stretch/>
        </p:blipFill>
        <p:spPr>
          <a:xfrm>
            <a:off x="4901474" y="797120"/>
            <a:ext cx="236255" cy="2780907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B5D3AC0-974F-5B45-AF22-6FF58BACFAF9}"/>
              </a:ext>
            </a:extLst>
          </p:cNvPr>
          <p:cNvSpPr/>
          <p:nvPr/>
        </p:nvSpPr>
        <p:spPr>
          <a:xfrm>
            <a:off x="5154064" y="1320311"/>
            <a:ext cx="3748761" cy="1012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EED51EDE-A22C-2947-8792-FA7C97226B38}"/>
              </a:ext>
            </a:extLst>
          </p:cNvPr>
          <p:cNvSpPr/>
          <p:nvPr/>
        </p:nvSpPr>
        <p:spPr>
          <a:xfrm>
            <a:off x="5140230" y="1158295"/>
            <a:ext cx="3767057" cy="23142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3008C29-8ED1-4248-8992-4EA203D45E5C}"/>
              </a:ext>
            </a:extLst>
          </p:cNvPr>
          <p:cNvSpPr/>
          <p:nvPr/>
        </p:nvSpPr>
        <p:spPr>
          <a:xfrm>
            <a:off x="1365194" y="3054575"/>
            <a:ext cx="235132" cy="1480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157AC05-73B7-5B40-9497-E7968CC58FA5}"/>
              </a:ext>
            </a:extLst>
          </p:cNvPr>
          <p:cNvSpPr/>
          <p:nvPr/>
        </p:nvSpPr>
        <p:spPr>
          <a:xfrm>
            <a:off x="314746" y="4182158"/>
            <a:ext cx="8514509" cy="22554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>
                <a:latin typeface="Arial" panose="020B0604020202020204" pitchFamily="34" charset="0"/>
                <a:ea typeface="游明朝" panose="02020400000000000000" pitchFamily="18" charset="-128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</a:rPr>
              <a:t>3.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The expression of EZH2 and H3K27me3 in non-neoplastic salivary gland tissues (n = 159), pleomorphic adenoma (PA) component (n = 18) and salivary duct carcinoma (SDC) (n = 226). a: The expression of EZH2 in PA was significantly higher than that in normal salivary gland tissue (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= 0.002), and that in SDC was higher than that in the PA component (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&lt; 0.001). b: In contrast, the expression of H3K27me3 in PA and SDC was higher than that in normal salivary gland tissue (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= 0.038 and &lt; 0.001, respectively); however, the H3K27me3 expression in the PA component and SDC did not show a statistically significant association.</a:t>
            </a:r>
            <a:endParaRPr lang="ja-JP" altLang="ja-JP" sz="120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671010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67</TotalTime>
  <Words>179</Words>
  <Application>Microsoft Macintosh PowerPoint</Application>
  <PresentationFormat>画面に合わせる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井 秀明</dc:creator>
  <cp:lastModifiedBy>平井 秀明</cp:lastModifiedBy>
  <cp:revision>90</cp:revision>
  <dcterms:created xsi:type="dcterms:W3CDTF">2020-07-01T13:22:00Z</dcterms:created>
  <dcterms:modified xsi:type="dcterms:W3CDTF">2021-09-20T00:15:00Z</dcterms:modified>
</cp:coreProperties>
</file>